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3A9BF2-6B6C-42AE-B0B1-BDB437FC7E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A1ABA2-E110-466A-84D7-4B832FAE0D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66C9B9-37B6-426F-B406-9100A3AC8EB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C40249-AE93-4D3D-9530-B66221F3D2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37F6D-F873-46BA-B355-1AF419F46B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F9E125-D966-4AA4-AC81-53C013DFE2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0678AE-9F54-4A16-9456-058F0E107A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9854FE-3FAB-444C-B855-B254781012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1AA310-C8F2-49AC-A9FC-91D410A576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019C56-2A5A-4E3F-90E9-B85EB76115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04D0B-9485-48DF-8A04-8DF5C87011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E843D5-47B9-4C8A-9929-4499612043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38DB8C-9BC1-43ED-BDEF-1CC88397A633}" type="slidenum">
              <a:rPr b="0" lang="pl-P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a 40"/>
          <p:cNvGrpSpPr/>
          <p:nvPr/>
        </p:nvGrpSpPr>
        <p:grpSpPr>
          <a:xfrm>
            <a:off x="2414520" y="652320"/>
            <a:ext cx="9639360" cy="6205680"/>
            <a:chOff x="2414520" y="652320"/>
            <a:chExt cx="9639360" cy="6205680"/>
          </a:xfrm>
        </p:grpSpPr>
        <p:sp>
          <p:nvSpPr>
            <p:cNvPr id="42" name="Łącznik prosty 5"/>
            <p:cNvSpPr/>
            <p:nvPr/>
          </p:nvSpPr>
          <p:spPr>
            <a:xfrm flipV="1">
              <a:off x="2414520" y="1390320"/>
              <a:ext cx="6654960" cy="3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pole tekstowe 7"/>
            <p:cNvSpPr/>
            <p:nvPr/>
          </p:nvSpPr>
          <p:spPr>
            <a:xfrm>
              <a:off x="4056480" y="1157760"/>
              <a:ext cx="653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Teff   Tre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pole tekstowe 10"/>
            <p:cNvSpPr/>
            <p:nvPr/>
          </p:nvSpPr>
          <p:spPr>
            <a:xfrm>
              <a:off x="4216320" y="958320"/>
              <a:ext cx="33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N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" name="Obraz 12" descr=""/>
            <p:cNvPicPr/>
            <p:nvPr/>
          </p:nvPicPr>
          <p:blipFill>
            <a:blip r:embed="rId1"/>
            <a:stretch/>
          </p:blipFill>
          <p:spPr>
            <a:xfrm>
              <a:off x="2589840" y="1288800"/>
              <a:ext cx="9464040" cy="5569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pole tekstowe 13"/>
            <p:cNvSpPr/>
            <p:nvPr/>
          </p:nvSpPr>
          <p:spPr>
            <a:xfrm>
              <a:off x="4703040" y="1157760"/>
              <a:ext cx="653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Teff   Tre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pole tekstowe 14"/>
            <p:cNvSpPr/>
            <p:nvPr/>
          </p:nvSpPr>
          <p:spPr>
            <a:xfrm>
              <a:off x="5363280" y="1160640"/>
              <a:ext cx="653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Teff   Tre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pole tekstowe 15"/>
            <p:cNvSpPr/>
            <p:nvPr/>
          </p:nvSpPr>
          <p:spPr>
            <a:xfrm>
              <a:off x="6060600" y="1164960"/>
              <a:ext cx="653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Teff   Tre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pole tekstowe 16"/>
            <p:cNvSpPr/>
            <p:nvPr/>
          </p:nvSpPr>
          <p:spPr>
            <a:xfrm>
              <a:off x="6720840" y="1164960"/>
              <a:ext cx="653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Teff   Tre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pole tekstowe 17"/>
            <p:cNvSpPr/>
            <p:nvPr/>
          </p:nvSpPr>
          <p:spPr>
            <a:xfrm>
              <a:off x="7417800" y="1174320"/>
              <a:ext cx="653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Teff   Tre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pole tekstowe 18"/>
            <p:cNvSpPr/>
            <p:nvPr/>
          </p:nvSpPr>
          <p:spPr>
            <a:xfrm>
              <a:off x="8346240" y="1153080"/>
              <a:ext cx="653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800" spc="-1" strike="noStrike">
                  <a:solidFill>
                    <a:srgbClr val="000000"/>
                  </a:solidFill>
                  <a:latin typeface="Arial"/>
                </a:rPr>
                <a:t>Teff   Tre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pole tekstowe 19"/>
            <p:cNvSpPr/>
            <p:nvPr/>
          </p:nvSpPr>
          <p:spPr>
            <a:xfrm>
              <a:off x="5536440" y="958680"/>
              <a:ext cx="33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N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pole tekstowe 20"/>
            <p:cNvSpPr/>
            <p:nvPr/>
          </p:nvSpPr>
          <p:spPr>
            <a:xfrm>
              <a:off x="6843240" y="958320"/>
              <a:ext cx="33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N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pole tekstowe 21"/>
            <p:cNvSpPr/>
            <p:nvPr/>
          </p:nvSpPr>
          <p:spPr>
            <a:xfrm>
              <a:off x="4789800" y="958320"/>
              <a:ext cx="511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DTA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pole tekstowe 22"/>
            <p:cNvSpPr/>
            <p:nvPr/>
          </p:nvSpPr>
          <p:spPr>
            <a:xfrm>
              <a:off x="6118560" y="954720"/>
              <a:ext cx="511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DTA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pole tekstowe 23"/>
            <p:cNvSpPr/>
            <p:nvPr/>
          </p:nvSpPr>
          <p:spPr>
            <a:xfrm>
              <a:off x="7435080" y="958320"/>
              <a:ext cx="511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DTA-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pole tekstowe 24"/>
            <p:cNvSpPr/>
            <p:nvPr/>
          </p:nvSpPr>
          <p:spPr>
            <a:xfrm>
              <a:off x="8367840" y="954720"/>
              <a:ext cx="625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TCRmini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Łącznik prosty 26"/>
            <p:cNvSpPr/>
            <p:nvPr/>
          </p:nvSpPr>
          <p:spPr>
            <a:xfrm flipV="1">
              <a:off x="2414520" y="2179440"/>
              <a:ext cx="6654960" cy="3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pole tekstowe 27"/>
            <p:cNvSpPr/>
            <p:nvPr/>
          </p:nvSpPr>
          <p:spPr>
            <a:xfrm>
              <a:off x="4471920" y="65232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pL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pole tekstowe 28"/>
            <p:cNvSpPr/>
            <p:nvPr/>
          </p:nvSpPr>
          <p:spPr>
            <a:xfrm>
              <a:off x="5829480" y="65592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dL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pole tekstowe 29"/>
            <p:cNvSpPr/>
            <p:nvPr/>
          </p:nvSpPr>
          <p:spPr>
            <a:xfrm>
              <a:off x="7107840" y="655920"/>
              <a:ext cx="42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TI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pole tekstowe 30"/>
            <p:cNvSpPr/>
            <p:nvPr/>
          </p:nvSpPr>
          <p:spPr>
            <a:xfrm>
              <a:off x="8415360" y="694440"/>
              <a:ext cx="41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pL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Łącznik prosty 31"/>
            <p:cNvSpPr/>
            <p:nvPr/>
          </p:nvSpPr>
          <p:spPr>
            <a:xfrm>
              <a:off x="4167000" y="955440"/>
              <a:ext cx="1090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Łącznik prosty 34"/>
            <p:cNvSpPr/>
            <p:nvPr/>
          </p:nvSpPr>
          <p:spPr>
            <a:xfrm>
              <a:off x="5448240" y="950760"/>
              <a:ext cx="1092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Łącznik prosty 35"/>
            <p:cNvSpPr/>
            <p:nvPr/>
          </p:nvSpPr>
          <p:spPr>
            <a:xfrm>
              <a:off x="6756480" y="956880"/>
              <a:ext cx="1092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Łącznik prosty 36"/>
            <p:cNvSpPr/>
            <p:nvPr/>
          </p:nvSpPr>
          <p:spPr>
            <a:xfrm flipV="1">
              <a:off x="8344080" y="940680"/>
              <a:ext cx="7254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" name="pole tekstowe 41"/>
          <p:cNvSpPr/>
          <p:nvPr/>
        </p:nvSpPr>
        <p:spPr>
          <a:xfrm>
            <a:off x="214200" y="5533920"/>
            <a:ext cx="119019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Supplementary Tabl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Frequencies of 2 Ep63K reactive and 14 endogenous  tumor antigen reactive TCRs in peripheral (pLN), drainining (dLN) lymph nodes or tumor infiltrating lymphocytes (TILs)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Of untreated (NT), DTA-1 treated or control unmanipulated (TCRmini) mice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10T11:51:42Z</dcterms:created>
  <dc:creator>E460</dc:creator>
  <dc:description/>
  <dc:language>en-US</dc:language>
  <cp:lastModifiedBy>AnnaS</cp:lastModifiedBy>
  <dcterms:modified xsi:type="dcterms:W3CDTF">2017-05-30T08:18:10Z</dcterms:modified>
  <cp:revision>12</cp:revision>
  <dc:subject/>
  <dc:title>Prezentacja programu PowerPoint</dc:title>
</cp:coreProperties>
</file>